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ola Stiuso" userId="5e2026c6-b1e5-4d54-845f-509f9900a388" providerId="ADAL" clId="{54857A82-4753-454A-8660-23AA9E02A2CA}"/>
    <pc:docChg chg="undo custSel modSld">
      <pc:chgData name="Paola Stiuso" userId="5e2026c6-b1e5-4d54-845f-509f9900a388" providerId="ADAL" clId="{54857A82-4753-454A-8660-23AA9E02A2CA}" dt="2024-03-08T12:41:18.414" v="7" actId="6549"/>
      <pc:docMkLst>
        <pc:docMk/>
      </pc:docMkLst>
      <pc:sldChg chg="modSp mod">
        <pc:chgData name="Paola Stiuso" userId="5e2026c6-b1e5-4d54-845f-509f9900a388" providerId="ADAL" clId="{54857A82-4753-454A-8660-23AA9E02A2CA}" dt="2024-03-08T12:41:18.414" v="7" actId="6549"/>
        <pc:sldMkLst>
          <pc:docMk/>
          <pc:sldMk cId="232336217" sldId="256"/>
        </pc:sldMkLst>
        <pc:spChg chg="mod">
          <ac:chgData name="Paola Stiuso" userId="5e2026c6-b1e5-4d54-845f-509f9900a388" providerId="ADAL" clId="{54857A82-4753-454A-8660-23AA9E02A2CA}" dt="2024-03-08T12:41:18.414" v="7" actId="6549"/>
          <ac:spMkLst>
            <pc:docMk/>
            <pc:sldMk cId="232336217" sldId="256"/>
            <ac:spMk id="5" creationId="{D12BEF4B-9B1E-1629-8AE9-90A8D0660DC8}"/>
          </ac:spMkLst>
        </pc:spChg>
      </pc:sldChg>
      <pc:sldChg chg="modSp mod">
        <pc:chgData name="Paola Stiuso" userId="5e2026c6-b1e5-4d54-845f-509f9900a388" providerId="ADAL" clId="{54857A82-4753-454A-8660-23AA9E02A2CA}" dt="2024-03-06T12:36:14.028" v="5" actId="20577"/>
        <pc:sldMkLst>
          <pc:docMk/>
          <pc:sldMk cId="1986119222" sldId="257"/>
        </pc:sldMkLst>
        <pc:spChg chg="mod">
          <ac:chgData name="Paola Stiuso" userId="5e2026c6-b1e5-4d54-845f-509f9900a388" providerId="ADAL" clId="{54857A82-4753-454A-8660-23AA9E02A2CA}" dt="2024-03-06T12:36:14.028" v="5" actId="20577"/>
          <ac:spMkLst>
            <pc:docMk/>
            <pc:sldMk cId="1986119222" sldId="257"/>
            <ac:spMk id="3" creationId="{56DF7D5D-B919-A9C4-C05D-C11F898042C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124383D-359C-C26D-A4A1-EE4AB64AF6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641D2B1-BB41-E3C5-CBB1-444AB5E831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D68FC10-20EE-D224-B387-523AD07A3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1D3750-D750-E2DC-FA4B-18DE66260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D796585-4D86-CD1F-A0E1-075A5063F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891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BF04993-AB96-E07E-CE40-EC4B2FD60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F3C110C-B8F5-AA2C-EAAD-EFFABC006D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16A2EAB-6ADD-8D06-4903-3A123AA76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05D73F7-F9EE-7410-49E1-A34625C0D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6A2E74-D113-0FB1-0C9F-86BFA07B7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0090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93B77FF-80ED-C98E-A4AE-809CB7957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6F5412D-6587-F7EE-E39A-837F1205C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54DB45-FB87-415B-D713-24357F411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AF13CC-65A3-E7AA-4377-03E47C3E2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0EC230-78AA-27EB-B063-90868F7AE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3658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5F0A26-81FB-C104-A358-6383343A2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912F877-79C0-D5DC-BF48-04FD82DD7E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8AD9C8-7BFC-21C6-EA4F-0AE5702C7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A65A12-02E4-6494-5DC1-91F2C16B0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2E14B60-CA95-D0D3-9554-C24CA4FD0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443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E1CCE1-E884-FB60-4B5E-26BEC3D54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65A9176-62FE-6816-82B1-51B8227555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9C099A-6036-09FA-0C99-A0AB360A7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EECE1E-E01B-74D5-1D14-3D63E18A9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5771C4-6020-D4D5-5307-ABD6BF968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1251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A6581C-ECCC-4BA5-FD0E-689A584F4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686F9C0-36C9-5660-BA50-DB39E4DAB8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3044C4-658A-71E0-E79A-838E2E336C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2428BE4-C75F-5336-C2C6-938F0FF8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1F18422-16E2-FC62-8599-D0F8E1494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3C162B1-EABE-B9D8-448E-A67DCA2DB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8371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DDCA11-91AE-31B8-9192-22063CA6FD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790C76C-A2CA-F622-1172-646807E4F9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531585-0803-7B6E-A4B7-CAEE26FBD7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77BAE2A-2D6A-942A-C540-96D14751CF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080CA82-18DB-E592-2236-C85E0F2BE8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A311A40-7D99-4BC1-870F-911D1C619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E41E90C-51C5-B363-2CFE-4AD0DB5BE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3CA8101-8DE3-E855-EB25-7CD332C0F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3432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AF7078-D002-C096-DDAC-03732B857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CB6BACD-CB8D-59E7-921A-E7E0ECF7B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49EBB3D-3FC5-8818-E616-9BBE79C77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560269D-F12B-AD49-9579-F8EA1C8F8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8477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D707FA6-9D83-14F7-F6E0-669646120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20BAA74-EE63-D14A-CEC0-824C54EF3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5980FA3-B419-D3B6-1D3D-1E079568C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6285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91833D-10DE-9C52-6E93-8D4B7C9CE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E850C0-FCE4-7EAA-C7A6-27317B39D3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2502320-3121-6728-C2E4-D43453D074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18C4205-5A08-5655-33BF-57F446CC6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E4A8B87-7F2C-9046-AD8B-C2ADF7B7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C34A704-C052-F024-7501-8D12B174B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8947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AB95A7-1FC9-1467-629B-59888B5D6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8D03458-189E-E840-E81C-F803EFF069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3481F39-189D-9660-69ED-DF493960D5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6F867B6-B615-3D35-27DD-FAAD4B187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7F3DE38-64DC-D5AE-ABE4-F3F5D8E39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29376A1-1685-03E1-CD3D-27CE4BB7F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3438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9521D53-81BE-79F8-FBA9-5514E3BEFA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F7A9965-5D72-7A1D-A433-0F7FD65567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ED3E99-9AAC-90B5-0DD5-AD0413F945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43173-A78B-4102-9CD4-0E2B52798F49}" type="datetimeFigureOut">
              <a:rPr lang="it-IT" smtClean="0"/>
              <a:t>08/03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DC7C50-C562-47F0-0CC8-6B06FAE724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E224CFE-4E12-A847-54A7-41AAA2C071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A1131-A1E7-4933-BBD7-E985843AB68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178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800781D4-9DA3-CB4A-0350-15F967A935A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1027" b="30999"/>
          <a:stretch/>
        </p:blipFill>
        <p:spPr bwMode="auto">
          <a:xfrm>
            <a:off x="1564644" y="1531302"/>
            <a:ext cx="4994910" cy="379539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D12BEF4B-9B1E-1629-8AE9-90A8D0660DC8}"/>
              </a:ext>
            </a:extLst>
          </p:cNvPr>
          <p:cNvSpPr txBox="1"/>
          <p:nvPr/>
        </p:nvSpPr>
        <p:spPr>
          <a:xfrm>
            <a:off x="1255114" y="5624945"/>
            <a:ext cx="55162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LAPE chromatogram acquired at 280 nm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323362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2373CA12-39D3-0D5D-80A3-FF26E9028B9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513" r="51027" b="32786"/>
          <a:stretch/>
        </p:blipFill>
        <p:spPr bwMode="auto">
          <a:xfrm>
            <a:off x="3594100" y="1787525"/>
            <a:ext cx="5003800" cy="328295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56DF7D5D-B919-A9C4-C05D-C11F898042C8}"/>
              </a:ext>
            </a:extLst>
          </p:cNvPr>
          <p:cNvSpPr txBox="1"/>
          <p:nvPr/>
        </p:nvSpPr>
        <p:spPr>
          <a:xfrm>
            <a:off x="4027055" y="5440218"/>
            <a:ext cx="7244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LAPE chromatogram acquired at 360 nm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861192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ola Stiuso</dc:creator>
  <cp:lastModifiedBy>Paola Stiuso</cp:lastModifiedBy>
  <cp:revision>2</cp:revision>
  <dcterms:created xsi:type="dcterms:W3CDTF">2022-09-13T08:33:08Z</dcterms:created>
  <dcterms:modified xsi:type="dcterms:W3CDTF">2024-03-08T12:41:26Z</dcterms:modified>
</cp:coreProperties>
</file>